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39D557-34FE-4A73-A9CD-B66412FFEC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36F80-849D-41A9-8F34-B07D59B142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CAF91-CE64-4D7A-9464-E543A01836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D78AE-41D6-4075-8028-911DD9B7DA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D794D-2D15-4F2E-B555-C758D47376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791DF-EDAD-4FA7-964A-5D391CA2D7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D8607-F77C-4C95-8F6E-7EB43016FC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E0480-11FD-41E6-A279-4E30E881E7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96F50-28D7-45A0-BF6D-37E9E6EA2D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73A60-89F1-48C8-9DD8-7231F4A8B9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1C0C3-2DCF-4AE0-9639-C070FB15BD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9EBBA-AF8F-403D-839B-C51A2902DE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E0F176-3370-497E-9094-AB7FC5E09971}" type="slidenum">
              <a:rPr b="0" lang="de-A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105"/>
          <p:cNvSpPr/>
          <p:nvPr/>
        </p:nvSpPr>
        <p:spPr>
          <a:xfrm>
            <a:off x="468360" y="474840"/>
            <a:ext cx="531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4. Primer Lis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022"/>
          <p:cNvSpPr/>
          <p:nvPr/>
        </p:nvSpPr>
        <p:spPr>
          <a:xfrm>
            <a:off x="2850120" y="16992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oerster et al., Table S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520560" y="847800"/>
          <a:ext cx="6120000" cy="8049960"/>
        </p:xfrm>
        <a:graphic>
          <a:graphicData uri="http://schemas.openxmlformats.org/drawingml/2006/table">
            <a:tbl>
              <a:tblPr/>
              <a:tblGrid>
                <a:gridCol w="844560"/>
                <a:gridCol w="2916360"/>
                <a:gridCol w="2359080"/>
              </a:tblGrid>
              <a:tr h="3938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 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 Sequence (5' to 3'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sed f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8 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C ACG AAA ACC AAA CAG 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8 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G GAA TTT CGA TCA ATC 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E3rt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T CTT CCA ACA CCA ACT CTG 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T-PCR (BME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ME3rt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 CTG AAT TGG CTA TGA GAA 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T-PCR (BME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 control 1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T CTG GTG ATT CAC CCA CTT CTG TTC TCA AC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 control 2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 TTG GTG ATT TAT TTA TTT TTG TTT TTA 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 control 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 TCA CTT TCT ATC CCA TTC 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A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T TGA GAT TTT TTA ATA AAG GGT AAT 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A-X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C CCC CAA AAT CCC CAA A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A-X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 AAA ACC CAC CAC CTC T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REP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T AAT AAT GTG TGA GTA TAA 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SREP-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A TAC RRT TAT CCA CAR AAT 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sulfite Sequenc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r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T CCT ATG TCT CCT ATG T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RT-PC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r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 AGT CCT TCA AGC TCA A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RT-PCR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7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 seq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T GAC CTA CAG GGC AGC 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RT-PCR, RT-PCR (P2 transcript), qPCR ChIP (P2), PCR ChIP 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62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G GGC TTG GAT GGT TCC 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northern, antisense RT-PCR, RT-PCR (P2 transcrip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AT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 AGT GGG TGT GGC CAT 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RT-PC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 CCG CTC GCC GCA GCC GAA 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norther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confir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A GTA ATG TTA GAT GTT CAA 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rev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A TGA CTC CAG TCT GTA T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R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T GGT TGG TCT GGG AGG TTG 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RT-PC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sm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T AAC ATG TAT TTG GAA AAA G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robe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 TAC GAA TTC CCA TGG AGT 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outhern blot (P35S+HPT prob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rob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T AGA GGA TCC CGG ACG A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outhern blot (P35S+HPT probe, HPT prob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Lank 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C GTC GCG AAC TAT ACA T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Lank 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G TTG AAT TGA ACT CTC CAC 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Rank 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A CAA ACA CTG ATT CAT CAT 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Rank 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T CAC CAC CGC ACA CAT T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3 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 GAT GTC GTA TTC GCT G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3 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A ACC TAT CAA CGC TTC 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M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G TAT TGA CCG ATT CCT TGC 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M3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C CAA TAC GAG GTC GCC 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norther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PTq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 TAA ATA GCT GCG CCG ATG GT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T-PCR, qPCR ChIP (HP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PTq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 GGC GGG AGA TGC AAT AGG TC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T-PCR, qPCR ChIP (HP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PT RT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 CCC CAT GTG TAT CAC 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PT RT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T CGG CGA GTA CTT CTA 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PT star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 CCC GGG GGA CAA TGA GAT 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4, Southern blot (HPT prob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ug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 TCT CAT TGT CCC CCG 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qPCR ChIP (P1), ChIP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L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 ACT TTG GCT ACA CCA 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outhern blot (180 bp prob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L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T CTT TGG CTT TGT GTC 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outhern blot (180 bp prob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35S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 TCT CAG AAG ACC AAA G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IP 3, ChIP 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62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35S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G ATA TCT CCA CTG ACG TAA G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isense northern, antisense RT-PCR, qPCR ChIP (P1/P2), RT-PCR (P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olita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 ATG GGA AGG TGA AAT GGC 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R ChIP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RNA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T GAC CAG TCC GCC AGC CGA 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mall RNA norther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40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RNA10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G CCA AGT TTG GCC TCA CGG T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mall RNA norther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6 prob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A TCC TTG CGC AGG GGC 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oly(A) norther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6T09:07:43Z</dcterms:created>
  <dc:creator>Andrea</dc:creator>
  <dc:description/>
  <dc:language>en-US</dc:language>
  <cp:lastModifiedBy>Mittelsten Scheid, Ortrun</cp:lastModifiedBy>
  <dcterms:modified xsi:type="dcterms:W3CDTF">2011-08-31T09:31:22Z</dcterms:modified>
  <cp:revision>113</cp:revision>
  <dc:subject/>
  <dc:title>Slide 1</dc:title>
</cp:coreProperties>
</file>